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1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0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F6C1F5-8893-050B-8F96-8D8B5F2D2DE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867CB5A-BCEE-4F37-A56E-31934F5EC9A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1890C1-53B3-B1AA-389B-82CE44720E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0ACDA-A862-415C-9CAD-143737E09524}" type="datetimeFigureOut">
              <a:rPr lang="nb-NO" smtClean="0"/>
              <a:t>03.05.2024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D6D165-9F0C-7363-5197-A0533F8FBD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E9EC38-4C67-795F-367D-9FC9157CDE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E78D9-4407-4355-B57B-2A897E5050F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5956944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4B2EB8-4FC7-D0CB-6D88-30A28FE1CA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B9298C-19FD-C053-0999-5CF29351AE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9088D1-3A8D-703E-0E43-7E745B1CA6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0ACDA-A862-415C-9CAD-143737E09524}" type="datetimeFigureOut">
              <a:rPr lang="nb-NO" smtClean="0"/>
              <a:t>03.05.2024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6D1D39-E53C-B516-130C-948244D247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6C8596-B6D1-78A0-1958-E15F5AF92E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E78D9-4407-4355-B57B-2A897E5050F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6215486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BEA019E-2151-A7A4-0D67-151ABE54387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0123204-66A2-175A-4CE0-03AAD3AE86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C7587B-F2E0-9E68-F30B-EB95B8FCAD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0ACDA-A862-415C-9CAD-143737E09524}" type="datetimeFigureOut">
              <a:rPr lang="nb-NO" smtClean="0"/>
              <a:t>03.05.2024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00CE19-CB1E-EDD8-C5CE-21FFA50C22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DEBD6C-B76B-CE40-BDD8-972E3FCBC2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E78D9-4407-4355-B57B-2A897E5050F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3000012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2D96FD-59E7-DF3D-E12F-1FA8D7259B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011342-05FB-6526-7B9D-783CFEA44E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24AF97-8523-79E5-0A38-560A0B11D6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0ACDA-A862-415C-9CAD-143737E09524}" type="datetimeFigureOut">
              <a:rPr lang="nb-NO" smtClean="0"/>
              <a:t>03.05.2024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490348-4733-AFAB-6548-CFF5296DAD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47640E-E9F6-DC2B-2A57-19CE55EE90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E78D9-4407-4355-B57B-2A897E5050F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4834767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B398B3-4E28-56D4-B83C-E3BF81AB8A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07231D-03EA-97CB-E47D-20A060A98C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D35A5E-92B2-1BB6-C25C-EF2F62F0E0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0ACDA-A862-415C-9CAD-143737E09524}" type="datetimeFigureOut">
              <a:rPr lang="nb-NO" smtClean="0"/>
              <a:t>03.05.2024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DE04B1-FA86-6309-7F3F-8F0DA81DA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A18CAF-34F0-1544-0C2E-99F477686A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E78D9-4407-4355-B57B-2A897E5050F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447141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CA0CE2-7979-C9DA-556E-33A886038B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F85F46-0AFE-7473-9F55-F93003C57A1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E8F1C50-7C80-FB80-D389-C27076FA51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CF002B-E875-6F7F-4845-4ED5A42174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0ACDA-A862-415C-9CAD-143737E09524}" type="datetimeFigureOut">
              <a:rPr lang="nb-NO" smtClean="0"/>
              <a:t>03.05.2024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D16E696-A58A-5BB8-6BEA-501BBC14E5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9FD017-5DC2-0A93-6634-9EAABF2740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E78D9-4407-4355-B57B-2A897E5050F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8259745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3ACBDA-E453-395A-136E-7555893466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847572-AE32-CA48-AB76-073B20CF91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ACDBED9-213B-14DB-7BE0-2845879C8B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31E41D8-65F0-0627-3B67-52A647A40D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A7EE510-A668-9F27-05DC-FFCC81EAA78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ECDB6E1-FD78-FA22-334C-A9EA007DEC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0ACDA-A862-415C-9CAD-143737E09524}" type="datetimeFigureOut">
              <a:rPr lang="nb-NO" smtClean="0"/>
              <a:t>03.05.2024</a:t>
            </a:fld>
            <a:endParaRPr lang="nb-NO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930AA23-CDED-72AB-37FF-7AF68E4FB0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F15B758-3919-1361-07E7-534B82EB83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E78D9-4407-4355-B57B-2A897E5050F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5168376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DDC341-F53C-1CE4-6036-08967B3344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26A0526-7612-69AF-F5D7-1C02C43F14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0ACDA-A862-415C-9CAD-143737E09524}" type="datetimeFigureOut">
              <a:rPr lang="nb-NO" smtClean="0"/>
              <a:t>03.05.2024</a:t>
            </a:fld>
            <a:endParaRPr lang="nb-NO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F9E3E1E-AA29-11DB-A56E-5F3D633EF2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BC610F7-C9B4-C64A-597B-D96DB20703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E78D9-4407-4355-B57B-2A897E5050F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8295613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3DF366A-95CD-8A78-83D6-EA1ABFD21C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0ACDA-A862-415C-9CAD-143737E09524}" type="datetimeFigureOut">
              <a:rPr lang="nb-NO" smtClean="0"/>
              <a:t>03.05.2024</a:t>
            </a:fld>
            <a:endParaRPr lang="nb-NO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1E40033-04F7-2E1E-3B3C-3628269148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6063A61-9CA6-0737-3ED5-CBB4654641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E78D9-4407-4355-B57B-2A897E5050F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1339225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A6F6FE-890C-A55A-2B4C-923E9AC415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6BD4D2-0E48-4092-5454-18188069F4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F9C6821-66AF-C1CA-F672-46C2BCA4B4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3E449A-0037-9A23-CBE9-03FE58642E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0ACDA-A862-415C-9CAD-143737E09524}" type="datetimeFigureOut">
              <a:rPr lang="nb-NO" smtClean="0"/>
              <a:t>03.05.2024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01A988E-E23F-A8CD-BF96-01BB6DF279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76ECAA8-8558-9F7B-39E9-712BACF023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E78D9-4407-4355-B57B-2A897E5050F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8394140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3AE135-BE03-654B-C6AC-91FF1DFBFB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B72DFAE-D7F4-D9D6-5C76-255206CE957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5E3A9AD-39DF-A566-4DDF-297108A470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9B106B-E870-5DDC-9FD0-250F04B578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D0ACDA-A862-415C-9CAD-143737E09524}" type="datetimeFigureOut">
              <a:rPr lang="nb-NO" smtClean="0"/>
              <a:t>03.05.2024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2DFAD7-E9E3-5987-298E-711A534E34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7DABB5F-4AF7-580B-250A-859797D9B2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0E78D9-4407-4355-B57B-2A897E5050F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65057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247E50F-8C4F-F286-A8AF-E1EA6466B6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C3B32BA-5958-32A1-3B34-DA59257F29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1BA927-08F7-D41C-32B4-5D2E5C7FBAA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D0ACDA-A862-415C-9CAD-143737E09524}" type="datetimeFigureOut">
              <a:rPr lang="nb-NO" smtClean="0"/>
              <a:t>03.05.2024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CC8D6A-8160-4B87-A15F-922D51ADEBB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16166A-3E67-BABD-E2B5-63AF02DE687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0E78D9-4407-4355-B57B-2A897E5050FD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7800969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3">
            <a:extLst>
              <a:ext uri="{FF2B5EF4-FFF2-40B4-BE49-F238E27FC236}">
                <a16:creationId xmlns:a16="http://schemas.microsoft.com/office/drawing/2014/main" id="{97214605-4C51-01DB-2119-35E96FFC98C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010925"/>
              </p:ext>
            </p:extLst>
          </p:nvPr>
        </p:nvGraphicFramePr>
        <p:xfrm>
          <a:off x="1569388" y="1252450"/>
          <a:ext cx="8795778" cy="3705523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540734">
                  <a:extLst>
                    <a:ext uri="{9D8B030D-6E8A-4147-A177-3AD203B41FA5}">
                      <a16:colId xmlns:a16="http://schemas.microsoft.com/office/drawing/2014/main" val="1563840277"/>
                    </a:ext>
                  </a:extLst>
                </a:gridCol>
                <a:gridCol w="1471256">
                  <a:extLst>
                    <a:ext uri="{9D8B030D-6E8A-4147-A177-3AD203B41FA5}">
                      <a16:colId xmlns:a16="http://schemas.microsoft.com/office/drawing/2014/main" val="916317864"/>
                    </a:ext>
                  </a:extLst>
                </a:gridCol>
                <a:gridCol w="2152679">
                  <a:extLst>
                    <a:ext uri="{9D8B030D-6E8A-4147-A177-3AD203B41FA5}">
                      <a16:colId xmlns:a16="http://schemas.microsoft.com/office/drawing/2014/main" val="3544056151"/>
                    </a:ext>
                  </a:extLst>
                </a:gridCol>
                <a:gridCol w="1153380">
                  <a:extLst>
                    <a:ext uri="{9D8B030D-6E8A-4147-A177-3AD203B41FA5}">
                      <a16:colId xmlns:a16="http://schemas.microsoft.com/office/drawing/2014/main" val="235155607"/>
                    </a:ext>
                  </a:extLst>
                </a:gridCol>
                <a:gridCol w="2477729">
                  <a:extLst>
                    <a:ext uri="{9D8B030D-6E8A-4147-A177-3AD203B41FA5}">
                      <a16:colId xmlns:a16="http://schemas.microsoft.com/office/drawing/2014/main" val="4011746397"/>
                    </a:ext>
                  </a:extLst>
                </a:gridCol>
              </a:tblGrid>
              <a:tr h="61971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</a:rPr>
                        <a:t>Pseudonym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</a:rPr>
                        <a:t>Age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</a:rPr>
                        <a:t>Category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</a:rPr>
                        <a:t>Years as F-A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b-NO" sz="16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port</a:t>
                      </a: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7810642"/>
                  </a:ext>
                </a:extLst>
              </a:tr>
              <a:tr h="3028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</a:rPr>
                        <a:t>Oliver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</a:rPr>
                        <a:t>25-29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hlete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6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oss-country </a:t>
                      </a:r>
                      <a:r>
                        <a:rPr lang="nb-NO" sz="1600" kern="1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kiing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16604467"/>
                  </a:ext>
                </a:extLst>
              </a:tr>
              <a:tr h="3028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 err="1">
                          <a:effectLst/>
                        </a:rPr>
                        <a:t>Matheo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</a:rPr>
                        <a:t>25-29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600" kern="1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hlete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b-NO" sz="16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oss-country </a:t>
                      </a:r>
                      <a:r>
                        <a:rPr lang="nb-NO" sz="1600" kern="1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kiing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24737378"/>
                  </a:ext>
                </a:extLst>
              </a:tr>
              <a:tr h="3028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</a:rPr>
                        <a:t>Liam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</a:rPr>
                        <a:t>30-35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600" kern="1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hlete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b-NO" sz="16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oss-country </a:t>
                      </a:r>
                      <a:r>
                        <a:rPr lang="nb-NO" sz="1600" kern="1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kiing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42657524"/>
                  </a:ext>
                </a:extLst>
              </a:tr>
              <a:tr h="3028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</a:rPr>
                        <a:t>Alfred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</a:rPr>
                        <a:t>25-29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600" kern="1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urrent</a:t>
                      </a:r>
                      <a:r>
                        <a:rPr lang="nb-NO" sz="16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nb-NO" sz="1600" kern="1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ather-athlete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</a:rPr>
                        <a:t>3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b-NO" sz="16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rdic </a:t>
                      </a:r>
                      <a:r>
                        <a:rPr lang="nb-NO" sz="1600" kern="1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mbined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56165803"/>
                  </a:ext>
                </a:extLst>
              </a:tr>
              <a:tr h="3028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 err="1">
                          <a:effectLst/>
                        </a:rPr>
                        <a:t>Ulrik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</a:rPr>
                        <a:t>30-35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600" kern="1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urrent</a:t>
                      </a:r>
                      <a:r>
                        <a:rPr lang="nb-NO" sz="16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nb-NO" sz="1600" kern="1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ather-athlete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</a:rPr>
                        <a:t>1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b-NO" sz="16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oss-country </a:t>
                      </a:r>
                      <a:r>
                        <a:rPr lang="nb-NO" sz="1600" kern="1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kiing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38445209"/>
                  </a:ext>
                </a:extLst>
              </a:tr>
              <a:tr h="31839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</a:rPr>
                        <a:t>Henrik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</a:rPr>
                        <a:t>30-35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600" kern="1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urrent</a:t>
                      </a:r>
                      <a:r>
                        <a:rPr lang="nb-NO" sz="16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nb-NO" sz="1600" kern="1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ather-athlete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</a:rPr>
                        <a:t>1.5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b-NO" sz="16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rdic </a:t>
                      </a:r>
                      <a:r>
                        <a:rPr lang="nb-NO" sz="1600" kern="1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mbined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68365559"/>
                  </a:ext>
                </a:extLst>
              </a:tr>
              <a:tr h="3028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</a:rPr>
                        <a:t>Olav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</a:rPr>
                        <a:t>30-35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600" kern="1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urrent</a:t>
                      </a:r>
                      <a:r>
                        <a:rPr lang="nb-NO" sz="16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nb-NO" sz="1600" kern="1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ather-athlete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</a:rPr>
                        <a:t>2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6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oss-country </a:t>
                      </a:r>
                      <a:r>
                        <a:rPr lang="nb-NO" sz="1600" kern="1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kiing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77284258"/>
                  </a:ext>
                </a:extLst>
              </a:tr>
              <a:tr h="3028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</a:rPr>
                        <a:t>Sander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</a:rPr>
                        <a:t>30-35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6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ormer </a:t>
                      </a:r>
                      <a:r>
                        <a:rPr lang="nb-NO" sz="1600" kern="1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ather-athlete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5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b-NO" sz="16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oss-country </a:t>
                      </a:r>
                      <a:r>
                        <a:rPr lang="nb-NO" sz="1600" kern="1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kiing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6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10002696"/>
                  </a:ext>
                </a:extLst>
              </a:tr>
              <a:tr h="34464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</a:rPr>
                        <a:t>Gustav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</a:rPr>
                        <a:t>40-45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6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ormer </a:t>
                      </a:r>
                      <a:r>
                        <a:rPr lang="nb-NO" sz="1600" kern="1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ather-athlete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</a:rPr>
                        <a:t>6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b-NO" sz="16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oss-country </a:t>
                      </a:r>
                      <a:r>
                        <a:rPr lang="nb-NO" sz="1600" kern="1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kiing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6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86376190"/>
                  </a:ext>
                </a:extLst>
              </a:tr>
              <a:tr h="30284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</a:rPr>
                        <a:t>Magnus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0-45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nb-NO" sz="16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ormer </a:t>
                      </a:r>
                      <a:r>
                        <a:rPr lang="nb-NO" sz="1600" kern="1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ather-athlete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kern="100" dirty="0">
                          <a:effectLst/>
                        </a:rPr>
                        <a:t>7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b-NO" sz="1600" kern="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oss-country </a:t>
                      </a:r>
                      <a:r>
                        <a:rPr lang="nb-NO" sz="1600" kern="100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kiing</a:t>
                      </a:r>
                      <a:endParaRPr lang="nb-NO" sz="16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solidFill>
                      <a:schemeClr val="bg1">
                        <a:lumMod val="6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1443660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525827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4</Words>
  <Application>Microsoft Office PowerPoint</Application>
  <PresentationFormat>Widescreen</PresentationFormat>
  <Paragraphs>5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x Bergström</dc:creator>
  <cp:lastModifiedBy>Max Bergström</cp:lastModifiedBy>
  <cp:revision>3</cp:revision>
  <dcterms:created xsi:type="dcterms:W3CDTF">2024-02-01T10:21:25Z</dcterms:created>
  <dcterms:modified xsi:type="dcterms:W3CDTF">2024-05-03T06:55:49Z</dcterms:modified>
</cp:coreProperties>
</file>